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7588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7239"/>
  </p:normalViewPr>
  <p:slideViewPr>
    <p:cSldViewPr snapToGrid="0" snapToObjects="1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3069" y="1122363"/>
            <a:ext cx="842145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449" y="3602038"/>
            <a:ext cx="743069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5880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7885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90118" y="365125"/>
            <a:ext cx="2136324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147" y="365125"/>
            <a:ext cx="6285126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1070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5132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987" y="1709740"/>
            <a:ext cx="854529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987" y="4589465"/>
            <a:ext cx="854529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8695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147" y="1825625"/>
            <a:ext cx="4210725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5716" y="1825625"/>
            <a:ext cx="4210725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220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437" y="365127"/>
            <a:ext cx="854529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438" y="1681163"/>
            <a:ext cx="419137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438" y="2505075"/>
            <a:ext cx="4191373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5717" y="1681163"/>
            <a:ext cx="421201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5717" y="2505075"/>
            <a:ext cx="4212015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439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4203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6737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437" y="457200"/>
            <a:ext cx="31954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2016" y="987427"/>
            <a:ext cx="5015716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437" y="2057400"/>
            <a:ext cx="31954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3035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437" y="457200"/>
            <a:ext cx="31954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2016" y="987427"/>
            <a:ext cx="5015716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437" y="2057400"/>
            <a:ext cx="31954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0491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147" y="365127"/>
            <a:ext cx="854529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147" y="1825625"/>
            <a:ext cx="854529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147" y="6356352"/>
            <a:ext cx="222920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ED666-3FA7-B844-B3EE-D8AD8CD540CB}" type="datetimeFigureOut">
              <a:rPr lang="fr-FR" smtClean="0"/>
              <a:t>13/04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889" y="6356352"/>
            <a:ext cx="334381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7234" y="6356352"/>
            <a:ext cx="222920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BF242-5D0E-EF45-8064-65A11926AA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0000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6FCE25D8-E0D0-E54C-954C-FB0E9F7924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" b="72933"/>
          <a:stretch/>
        </p:blipFill>
        <p:spPr>
          <a:xfrm>
            <a:off x="807345" y="2120677"/>
            <a:ext cx="4160559" cy="525283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E23F453F-55BC-3744-B3E3-2E9776F5B2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72935"/>
          <a:stretch/>
        </p:blipFill>
        <p:spPr>
          <a:xfrm>
            <a:off x="5551976" y="2120676"/>
            <a:ext cx="4185414" cy="525285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2A6B9C2-F0E5-BD46-827A-30C594BDB7C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5396" b="2208"/>
          <a:stretch/>
        </p:blipFill>
        <p:spPr>
          <a:xfrm>
            <a:off x="807345" y="2649552"/>
            <a:ext cx="4160559" cy="46505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83DCCD33-C383-284B-8EF2-2D9BA63163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095" b="1509"/>
          <a:stretch/>
        </p:blipFill>
        <p:spPr>
          <a:xfrm>
            <a:off x="5551976" y="2649048"/>
            <a:ext cx="4185414" cy="46505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D7A85142-6638-4B49-936E-6CE24F00E7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359" b="74268"/>
          <a:stretch/>
        </p:blipFill>
        <p:spPr>
          <a:xfrm>
            <a:off x="802561" y="1218468"/>
            <a:ext cx="4165343" cy="522435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A26ED14A-CE88-2144-B809-3F33C13F69F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835" b="73038"/>
          <a:stretch/>
        </p:blipFill>
        <p:spPr>
          <a:xfrm>
            <a:off x="807346" y="3028667"/>
            <a:ext cx="4167300" cy="523286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8BA43E74-D18C-F143-9D50-E49E324ED88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73030"/>
          <a:stretch/>
        </p:blipFill>
        <p:spPr>
          <a:xfrm>
            <a:off x="816024" y="3884563"/>
            <a:ext cx="4143184" cy="52344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C6EB3F00-BC58-3F4F-B7F2-4B97D5B8DCA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74267"/>
          <a:stretch/>
        </p:blipFill>
        <p:spPr>
          <a:xfrm>
            <a:off x="5547192" y="1218468"/>
            <a:ext cx="4235131" cy="522437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7E00322A-CA39-E94B-9DB5-7EEA9AC5F74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73038"/>
          <a:stretch/>
        </p:blipFill>
        <p:spPr>
          <a:xfrm>
            <a:off x="5545625" y="3028669"/>
            <a:ext cx="4202030" cy="523285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C195F1F2-A209-904F-A59D-79A02156941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" b="73029"/>
          <a:stretch/>
        </p:blipFill>
        <p:spPr>
          <a:xfrm>
            <a:off x="5531764" y="3884563"/>
            <a:ext cx="4179001" cy="523440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9D3C8EF5-96B9-8547-AE96-90CB7250B6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5396" b="2208"/>
          <a:stretch/>
        </p:blipFill>
        <p:spPr>
          <a:xfrm>
            <a:off x="800605" y="1744126"/>
            <a:ext cx="4160559" cy="46505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1784F08C-BB99-5847-9DB7-A4B73FF3D9F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095" b="1509"/>
          <a:stretch/>
        </p:blipFill>
        <p:spPr>
          <a:xfrm>
            <a:off x="5551975" y="1739580"/>
            <a:ext cx="4230348" cy="47005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9476D687-CB2C-6A42-8A57-01A06721634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5396" b="2208"/>
          <a:stretch/>
        </p:blipFill>
        <p:spPr>
          <a:xfrm>
            <a:off x="807345" y="3551450"/>
            <a:ext cx="4160559" cy="46505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677B99AB-318F-8943-894C-575EE885DBA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095" b="1509"/>
          <a:stretch/>
        </p:blipFill>
        <p:spPr>
          <a:xfrm>
            <a:off x="5545246" y="3551450"/>
            <a:ext cx="4185414" cy="46505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9E0D009D-4523-304B-8187-A7F9A5DC72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5396" b="2208"/>
          <a:stretch/>
        </p:blipFill>
        <p:spPr>
          <a:xfrm>
            <a:off x="800605" y="4428787"/>
            <a:ext cx="4160559" cy="46505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B7C7838F-01D5-2845-B106-5622EC2C4DC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095" b="1509"/>
          <a:stretch/>
        </p:blipFill>
        <p:spPr>
          <a:xfrm>
            <a:off x="5531764" y="4416976"/>
            <a:ext cx="4185414" cy="46505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F5DEBA33-2E1F-AF40-9F8C-D6291C1F8723}"/>
              </a:ext>
            </a:extLst>
          </p:cNvPr>
          <p:cNvSpPr/>
          <p:nvPr/>
        </p:nvSpPr>
        <p:spPr>
          <a:xfrm>
            <a:off x="1654692" y="1135245"/>
            <a:ext cx="447770" cy="3453786"/>
          </a:xfrm>
          <a:prstGeom prst="rect">
            <a:avLst/>
          </a:prstGeom>
          <a:noFill/>
          <a:ln w="38100">
            <a:solidFill>
              <a:srgbClr val="00B05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4307" tIns="37153" rIns="74307" bIns="3715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 sz="1463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FFCF63E-7F4A-8644-A21F-10FD0CF34848}"/>
              </a:ext>
            </a:extLst>
          </p:cNvPr>
          <p:cNvSpPr/>
          <p:nvPr/>
        </p:nvSpPr>
        <p:spPr>
          <a:xfrm>
            <a:off x="2717244" y="1135245"/>
            <a:ext cx="492382" cy="3453786"/>
          </a:xfrm>
          <a:prstGeom prst="rect">
            <a:avLst/>
          </a:prstGeom>
          <a:noFill/>
          <a:ln w="38100">
            <a:solidFill>
              <a:srgbClr val="00206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4307" tIns="37153" rIns="74307" bIns="3715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 sz="1463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F47F0BA-1732-3E42-97F4-E25F4C50BEAD}"/>
              </a:ext>
            </a:extLst>
          </p:cNvPr>
          <p:cNvSpPr/>
          <p:nvPr/>
        </p:nvSpPr>
        <p:spPr>
          <a:xfrm>
            <a:off x="3822604" y="1135245"/>
            <a:ext cx="444863" cy="3453786"/>
          </a:xfrm>
          <a:prstGeom prst="rect">
            <a:avLst/>
          </a:prstGeom>
          <a:noFill/>
          <a:ln w="38100">
            <a:solidFill>
              <a:srgbClr val="EA9F2A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4307" tIns="37153" rIns="74307" bIns="3715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 sz="1463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F3B77B6-AF33-7049-BA25-524D0338923B}"/>
              </a:ext>
            </a:extLst>
          </p:cNvPr>
          <p:cNvSpPr/>
          <p:nvPr/>
        </p:nvSpPr>
        <p:spPr>
          <a:xfrm>
            <a:off x="6070277" y="1135245"/>
            <a:ext cx="1035622" cy="3453786"/>
          </a:xfrm>
          <a:prstGeom prst="rect">
            <a:avLst/>
          </a:prstGeom>
          <a:noFill/>
          <a:ln w="38100">
            <a:solidFill>
              <a:srgbClr val="00B05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4307" tIns="37153" rIns="74307" bIns="3715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 sz="1463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02A38AD-9FBA-194F-AAD4-7AD556037978}"/>
              </a:ext>
            </a:extLst>
          </p:cNvPr>
          <p:cNvSpPr/>
          <p:nvPr/>
        </p:nvSpPr>
        <p:spPr>
          <a:xfrm>
            <a:off x="7263585" y="1135245"/>
            <a:ext cx="1035622" cy="3453786"/>
          </a:xfrm>
          <a:prstGeom prst="rect">
            <a:avLst/>
          </a:prstGeom>
          <a:noFill/>
          <a:ln w="38100">
            <a:solidFill>
              <a:srgbClr val="00206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4307" tIns="37153" rIns="74307" bIns="3715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 sz="1463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2D958FA-D1A8-C144-9EDD-98B900E32CC6}"/>
              </a:ext>
            </a:extLst>
          </p:cNvPr>
          <p:cNvSpPr/>
          <p:nvPr/>
        </p:nvSpPr>
        <p:spPr>
          <a:xfrm>
            <a:off x="8456894" y="1135245"/>
            <a:ext cx="1075939" cy="3453786"/>
          </a:xfrm>
          <a:prstGeom prst="rect">
            <a:avLst/>
          </a:prstGeom>
          <a:noFill/>
          <a:ln w="38100">
            <a:solidFill>
              <a:srgbClr val="EA9F2A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74307" tIns="37153" rIns="74307" bIns="3715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fr-FR" sz="1463"/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5A603702-E984-404D-B876-9D1184D37571}"/>
              </a:ext>
            </a:extLst>
          </p:cNvPr>
          <p:cNvSpPr txBox="1"/>
          <p:nvPr/>
        </p:nvSpPr>
        <p:spPr>
          <a:xfrm>
            <a:off x="3920626" y="4668510"/>
            <a:ext cx="243964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dirty="0">
                <a:latin typeface="Palatino Linotype" panose="02040502050505030304" pitchFamily="18" charset="0"/>
                <a:ea typeface="Palatino" pitchFamily="2" charset="77"/>
              </a:rPr>
              <a:t>1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D46AF7BA-00DB-7A4B-9C9D-916346731AA7}"/>
              </a:ext>
            </a:extLst>
          </p:cNvPr>
          <p:cNvSpPr txBox="1"/>
          <p:nvPr/>
        </p:nvSpPr>
        <p:spPr>
          <a:xfrm>
            <a:off x="8833670" y="4668509"/>
            <a:ext cx="362958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dirty="0">
                <a:latin typeface="Palatino Linotype" panose="02040502050505030304" pitchFamily="18" charset="0"/>
                <a:ea typeface="Palatino" pitchFamily="2" charset="77"/>
              </a:rPr>
              <a:t>1’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335E3B71-A966-1C46-941F-1B1DC894A733}"/>
              </a:ext>
            </a:extLst>
          </p:cNvPr>
          <p:cNvSpPr txBox="1"/>
          <p:nvPr/>
        </p:nvSpPr>
        <p:spPr>
          <a:xfrm>
            <a:off x="2841452" y="4668674"/>
            <a:ext cx="243964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dirty="0">
                <a:latin typeface="Palatino Linotype" panose="02040502050505030304" pitchFamily="18" charset="0"/>
                <a:ea typeface="Palatino" pitchFamily="2" charset="77"/>
              </a:rPr>
              <a:t>2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ED972183-2131-3A4F-833E-24D8518F5C92}"/>
              </a:ext>
            </a:extLst>
          </p:cNvPr>
          <p:cNvSpPr txBox="1"/>
          <p:nvPr/>
        </p:nvSpPr>
        <p:spPr>
          <a:xfrm>
            <a:off x="1745367" y="4668674"/>
            <a:ext cx="243964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dirty="0">
                <a:latin typeface="Palatino Linotype" panose="02040502050505030304" pitchFamily="18" charset="0"/>
                <a:ea typeface="Palatino" pitchFamily="2" charset="77"/>
              </a:rPr>
              <a:t>3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9C8BCB67-9D8B-734B-A276-159916320A66}"/>
              </a:ext>
            </a:extLst>
          </p:cNvPr>
          <p:cNvSpPr txBox="1"/>
          <p:nvPr/>
        </p:nvSpPr>
        <p:spPr>
          <a:xfrm>
            <a:off x="7659413" y="4668674"/>
            <a:ext cx="367714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dirty="0">
                <a:latin typeface="Palatino Linotype" panose="02040502050505030304" pitchFamily="18" charset="0"/>
                <a:ea typeface="Palatino" pitchFamily="2" charset="77"/>
              </a:rPr>
              <a:t>2’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00BC3D0D-FB48-8749-8993-89F05A8CFA3B}"/>
              </a:ext>
            </a:extLst>
          </p:cNvPr>
          <p:cNvSpPr txBox="1"/>
          <p:nvPr/>
        </p:nvSpPr>
        <p:spPr>
          <a:xfrm>
            <a:off x="6498751" y="4668510"/>
            <a:ext cx="363716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dirty="0">
                <a:latin typeface="Palatino Linotype" panose="02040502050505030304" pitchFamily="18" charset="0"/>
                <a:ea typeface="Palatino" pitchFamily="2" charset="77"/>
              </a:rPr>
              <a:t>3’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A942D8F4-84FE-2C44-8DC0-04F8816F93AB}"/>
              </a:ext>
            </a:extLst>
          </p:cNvPr>
          <p:cNvSpPr txBox="1"/>
          <p:nvPr/>
        </p:nvSpPr>
        <p:spPr>
          <a:xfrm>
            <a:off x="7535714" y="642491"/>
            <a:ext cx="53572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300" b="1" i="1" dirty="0">
                <a:latin typeface="Palatino Linotype" panose="02040502050505030304" pitchFamily="18" charset="0"/>
                <a:ea typeface="Palatino" pitchFamily="2" charset="77"/>
                <a:cs typeface="Arial"/>
              </a:rPr>
              <a:t>NEB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559FB9EB-502E-BB41-AAAA-B74BD2DDB30D}"/>
              </a:ext>
            </a:extLst>
          </p:cNvPr>
          <p:cNvSpPr txBox="1"/>
          <p:nvPr/>
        </p:nvSpPr>
        <p:spPr>
          <a:xfrm>
            <a:off x="2726872" y="642491"/>
            <a:ext cx="51969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300" b="1" i="1" dirty="0">
                <a:latin typeface="Palatino Linotype" panose="02040502050505030304" pitchFamily="18" charset="0"/>
                <a:ea typeface="Palatino" pitchFamily="2" charset="77"/>
                <a:cs typeface="Arial"/>
              </a:rPr>
              <a:t>TT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85F3D6A-EB88-7A41-B42A-99B55944D66B}"/>
              </a:ext>
            </a:extLst>
          </p:cNvPr>
          <p:cNvSpPr/>
          <p:nvPr/>
        </p:nvSpPr>
        <p:spPr>
          <a:xfrm>
            <a:off x="1" y="5111778"/>
            <a:ext cx="9907588" cy="1055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94" b="1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upplementary</a:t>
            </a:r>
            <a:r>
              <a:rPr lang="fr-FR" sz="894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Figure 1.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ntegrativ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Genomic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Viewer (IGV)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visualizatio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f </a:t>
            </a:r>
            <a:r>
              <a:rPr lang="fr-FR" sz="894" i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T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NM_001267550) and </a:t>
            </a:r>
            <a:r>
              <a:rPr lang="fr-FR" sz="894" i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EB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NM_001271208)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peated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gio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ad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different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capture kits. </a:t>
            </a:r>
            <a:r>
              <a:rPr lang="fr-FR" sz="894" i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T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has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hre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peat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1, 2 and 3) of 8 exons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ontaining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spectively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exons 172 to 180, 181 to 189 and 190 to 198. </a:t>
            </a:r>
            <a:r>
              <a:rPr lang="fr-FR" sz="894" i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EB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has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hre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peat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1’, 2’ and 3’) of 7 exons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ontaining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spectively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exons 82 to 89,  90 to 97 and 98 to 105. IGV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view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f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ad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lignment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f </a:t>
            </a:r>
            <a:r>
              <a:rPr lang="fr-FR" sz="894" i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T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A, B, C and D) and </a:t>
            </a:r>
            <a:r>
              <a:rPr lang="fr-FR" sz="894" i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EB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E, F, G and H),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ccording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to four capture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ethod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: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gen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panel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argeted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eqCap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EZ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hoic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library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Roche-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imbleGe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) (A, E) ; Roche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imbleGe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eqCap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EZ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edExom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B, F);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gilent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ureSelect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Huma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ll Exon V7 (C, G);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gilent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ureSelect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linical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search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Exom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V2 (D, H).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ad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apping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quality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f 60,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eaning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ad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apped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t a unique site, are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illed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in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grey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herea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ad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apping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quality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f 0,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eaning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read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apped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t multiple locations, are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illed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in white. In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each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case,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depth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f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overage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s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hown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in the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upper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894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left</a:t>
            </a:r>
            <a:r>
              <a:rPr lang="fr-FR" sz="894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corner. </a:t>
            </a:r>
          </a:p>
          <a:p>
            <a:endParaRPr lang="fr-FR" sz="894" dirty="0">
              <a:latin typeface="Palatino Linotype" panose="02040502050505030304" pitchFamily="18" charset="0"/>
              <a:ea typeface="Palatino" pitchFamily="2" charset="77"/>
              <a:cs typeface="Arial" panose="020B0604020202020204" pitchFamily="34" charset="0"/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D539D824-C451-3643-BDA7-F8F25A2D9EB1}"/>
              </a:ext>
            </a:extLst>
          </p:cNvPr>
          <p:cNvSpPr txBox="1"/>
          <p:nvPr/>
        </p:nvSpPr>
        <p:spPr>
          <a:xfrm>
            <a:off x="-46735" y="1344246"/>
            <a:ext cx="154374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75" dirty="0">
                <a:latin typeface="Palatino Linotype" panose="02040502050505030304" pitchFamily="18" charset="0"/>
                <a:cs typeface="Arial" panose="020B0604020202020204" pitchFamily="34" charset="0"/>
              </a:rPr>
              <a:t>Roche</a:t>
            </a:r>
          </a:p>
          <a:p>
            <a:r>
              <a:rPr lang="fr-FR" sz="975" dirty="0">
                <a:latin typeface="Palatino Linotype" panose="02040502050505030304" pitchFamily="18" charset="0"/>
                <a:cs typeface="Arial" panose="020B0604020202020204" pitchFamily="34" charset="0"/>
              </a:rPr>
              <a:t>Gene Panel 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2FF85218-D7B0-AF45-864F-C805E8CAC4D5}"/>
              </a:ext>
            </a:extLst>
          </p:cNvPr>
          <p:cNvSpPr txBox="1"/>
          <p:nvPr/>
        </p:nvSpPr>
        <p:spPr>
          <a:xfrm>
            <a:off x="-46735" y="2282109"/>
            <a:ext cx="1533307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75" dirty="0">
                <a:latin typeface="Palatino Linotype" panose="02040502050505030304" pitchFamily="18" charset="0"/>
                <a:cs typeface="Arial" panose="020B0604020202020204" pitchFamily="34" charset="0"/>
              </a:rPr>
              <a:t>Roche</a:t>
            </a:r>
          </a:p>
          <a:p>
            <a:r>
              <a:rPr lang="fr-FR" sz="975" dirty="0" err="1">
                <a:latin typeface="Palatino Linotype" panose="02040502050505030304" pitchFamily="18" charset="0"/>
                <a:cs typeface="Arial" panose="020B0604020202020204" pitchFamily="34" charset="0"/>
              </a:rPr>
              <a:t>Medexome</a:t>
            </a:r>
            <a:endParaRPr lang="fr-FR" sz="975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41AC4512-B085-794F-9BD5-D1BD54B119CF}"/>
              </a:ext>
            </a:extLst>
          </p:cNvPr>
          <p:cNvSpPr txBox="1"/>
          <p:nvPr/>
        </p:nvSpPr>
        <p:spPr>
          <a:xfrm>
            <a:off x="-46735" y="3195317"/>
            <a:ext cx="1511068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75" dirty="0" err="1">
                <a:latin typeface="Palatino Linotype" panose="02040502050505030304" pitchFamily="18" charset="0"/>
                <a:cs typeface="Arial" panose="020B0604020202020204" pitchFamily="34" charset="0"/>
              </a:rPr>
              <a:t>Agilent</a:t>
            </a:r>
            <a:endParaRPr lang="fr-FR" sz="975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r>
              <a:rPr lang="fr-FR" sz="975" dirty="0">
                <a:latin typeface="Palatino Linotype" panose="02040502050505030304" pitchFamily="18" charset="0"/>
                <a:cs typeface="Arial" panose="020B0604020202020204" pitchFamily="34" charset="0"/>
              </a:rPr>
              <a:t>CREV2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DAC20B26-1A43-364F-886F-9FB507B84DD7}"/>
              </a:ext>
            </a:extLst>
          </p:cNvPr>
          <p:cNvSpPr txBox="1"/>
          <p:nvPr/>
        </p:nvSpPr>
        <p:spPr>
          <a:xfrm>
            <a:off x="-44897" y="4121213"/>
            <a:ext cx="1482772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75" dirty="0" err="1">
                <a:latin typeface="Palatino Linotype" panose="02040502050505030304" pitchFamily="18" charset="0"/>
                <a:cs typeface="Arial" panose="020B0604020202020204" pitchFamily="34" charset="0"/>
              </a:rPr>
              <a:t>Agilent</a:t>
            </a:r>
            <a:endParaRPr lang="fr-FR" sz="975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r>
              <a:rPr lang="fr-FR" sz="975" dirty="0">
                <a:latin typeface="Palatino Linotype" panose="02040502050505030304" pitchFamily="18" charset="0"/>
                <a:cs typeface="Arial" panose="020B0604020202020204" pitchFamily="34" charset="0"/>
              </a:rPr>
              <a:t>SSV7</a:t>
            </a:r>
          </a:p>
        </p:txBody>
      </p: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E840F391-2E80-F24A-B55A-6921E2E60586}"/>
              </a:ext>
            </a:extLst>
          </p:cNvPr>
          <p:cNvCxnSpPr>
            <a:cxnSpLocks/>
          </p:cNvCxnSpPr>
          <p:nvPr/>
        </p:nvCxnSpPr>
        <p:spPr>
          <a:xfrm>
            <a:off x="5267006" y="335668"/>
            <a:ext cx="1035" cy="4564096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ZoneTexte 42">
            <a:extLst>
              <a:ext uri="{FF2B5EF4-FFF2-40B4-BE49-F238E27FC236}">
                <a16:creationId xmlns:a16="http://schemas.microsoft.com/office/drawing/2014/main" id="{C09B0DF0-86B4-484F-90B5-40CD94249D61}"/>
              </a:ext>
            </a:extLst>
          </p:cNvPr>
          <p:cNvSpPr txBox="1"/>
          <p:nvPr/>
        </p:nvSpPr>
        <p:spPr>
          <a:xfrm>
            <a:off x="791172" y="1204201"/>
            <a:ext cx="470884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815]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C11EB721-786E-6C4C-B40D-FF675DF731C9}"/>
              </a:ext>
            </a:extLst>
          </p:cNvPr>
          <p:cNvSpPr txBox="1"/>
          <p:nvPr/>
        </p:nvSpPr>
        <p:spPr>
          <a:xfrm>
            <a:off x="798408" y="2116708"/>
            <a:ext cx="470884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578]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BD82F3C3-FDFD-4A4B-975D-A9AB6B139BD5}"/>
              </a:ext>
            </a:extLst>
          </p:cNvPr>
          <p:cNvSpPr txBox="1"/>
          <p:nvPr/>
        </p:nvSpPr>
        <p:spPr>
          <a:xfrm>
            <a:off x="789535" y="3023485"/>
            <a:ext cx="470884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234]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43B5DF49-3E2A-1049-BF15-013E25B0324A}"/>
              </a:ext>
            </a:extLst>
          </p:cNvPr>
          <p:cNvSpPr txBox="1"/>
          <p:nvPr/>
        </p:nvSpPr>
        <p:spPr>
          <a:xfrm>
            <a:off x="812059" y="3884563"/>
            <a:ext cx="470884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918]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CEF81653-DA2F-DE43-A8EA-6BFEE8EF4191}"/>
              </a:ext>
            </a:extLst>
          </p:cNvPr>
          <p:cNvSpPr txBox="1"/>
          <p:nvPr/>
        </p:nvSpPr>
        <p:spPr>
          <a:xfrm>
            <a:off x="5542956" y="1217520"/>
            <a:ext cx="678089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1265]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0EC80E36-5ABD-D14D-B891-5CCA0624F567}"/>
              </a:ext>
            </a:extLst>
          </p:cNvPr>
          <p:cNvSpPr txBox="1"/>
          <p:nvPr/>
        </p:nvSpPr>
        <p:spPr>
          <a:xfrm>
            <a:off x="5536064" y="2117588"/>
            <a:ext cx="534922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453]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B074AF07-6406-C842-81E7-B5CD9E50CC95}"/>
              </a:ext>
            </a:extLst>
          </p:cNvPr>
          <p:cNvSpPr txBox="1"/>
          <p:nvPr/>
        </p:nvSpPr>
        <p:spPr>
          <a:xfrm>
            <a:off x="5548104" y="3029617"/>
            <a:ext cx="534922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945]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3FB48BBB-1218-F148-8108-42A9A89B4A76}"/>
              </a:ext>
            </a:extLst>
          </p:cNvPr>
          <p:cNvSpPr txBox="1"/>
          <p:nvPr/>
        </p:nvSpPr>
        <p:spPr>
          <a:xfrm>
            <a:off x="5521880" y="3881697"/>
            <a:ext cx="534922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dirty="0">
                <a:latin typeface="Palatino Linotype" panose="02040502050505030304" pitchFamily="18" charset="0"/>
              </a:rPr>
              <a:t>[0 - 832]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F90B33AD-3045-0F43-87D4-FEC9C02C0B30}"/>
              </a:ext>
            </a:extLst>
          </p:cNvPr>
          <p:cNvSpPr txBox="1"/>
          <p:nvPr/>
        </p:nvSpPr>
        <p:spPr>
          <a:xfrm>
            <a:off x="545544" y="1098036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A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A123F171-24A9-0946-A536-0AB6350B5C3E}"/>
              </a:ext>
            </a:extLst>
          </p:cNvPr>
          <p:cNvSpPr txBox="1"/>
          <p:nvPr/>
        </p:nvSpPr>
        <p:spPr>
          <a:xfrm>
            <a:off x="543216" y="2002682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B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560D44EC-8FBA-E946-AFFC-E056CEA61EE2}"/>
              </a:ext>
            </a:extLst>
          </p:cNvPr>
          <p:cNvSpPr txBox="1"/>
          <p:nvPr/>
        </p:nvSpPr>
        <p:spPr>
          <a:xfrm>
            <a:off x="567836" y="2928193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C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C8B0F032-B779-3843-9EFF-4B875A6B6F30}"/>
              </a:ext>
            </a:extLst>
          </p:cNvPr>
          <p:cNvSpPr txBox="1"/>
          <p:nvPr/>
        </p:nvSpPr>
        <p:spPr>
          <a:xfrm>
            <a:off x="559520" y="3794919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D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26E9293E-FAC8-CD4D-B09E-FB8C79EAE41F}"/>
              </a:ext>
            </a:extLst>
          </p:cNvPr>
          <p:cNvSpPr txBox="1"/>
          <p:nvPr/>
        </p:nvSpPr>
        <p:spPr>
          <a:xfrm>
            <a:off x="5305024" y="1109614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E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81D54FCD-144B-2C49-99CD-7E3A5C3C8C69}"/>
              </a:ext>
            </a:extLst>
          </p:cNvPr>
          <p:cNvSpPr txBox="1"/>
          <p:nvPr/>
        </p:nvSpPr>
        <p:spPr>
          <a:xfrm>
            <a:off x="5302696" y="2014260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F</a:t>
            </a: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23E0C905-E0F4-404E-B75A-1DA64369BBF9}"/>
              </a:ext>
            </a:extLst>
          </p:cNvPr>
          <p:cNvSpPr txBox="1"/>
          <p:nvPr/>
        </p:nvSpPr>
        <p:spPr>
          <a:xfrm>
            <a:off x="5292591" y="2939771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G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24706525-309E-8344-8FB9-B707142BFCDF}"/>
              </a:ext>
            </a:extLst>
          </p:cNvPr>
          <p:cNvSpPr txBox="1"/>
          <p:nvPr/>
        </p:nvSpPr>
        <p:spPr>
          <a:xfrm>
            <a:off x="5284275" y="3806497"/>
            <a:ext cx="372617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63" b="1" dirty="0">
                <a:ea typeface="Palatino" pitchFamily="2" charset="77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31252490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297</Words>
  <Application>Microsoft Macintosh PowerPoint</Application>
  <PresentationFormat>Personnalisé</PresentationFormat>
  <Paragraphs>3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rles VAN GOETHEM</dc:creator>
  <cp:lastModifiedBy>Mireille Cossée</cp:lastModifiedBy>
  <cp:revision>7</cp:revision>
  <cp:lastPrinted>2023-04-13T14:40:26Z</cp:lastPrinted>
  <dcterms:created xsi:type="dcterms:W3CDTF">2023-04-13T13:46:36Z</dcterms:created>
  <dcterms:modified xsi:type="dcterms:W3CDTF">2023-04-13T16:09:46Z</dcterms:modified>
</cp:coreProperties>
</file>